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907588" cy="6858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35600" cy="98676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0"/>
            <a:ext cx="6735600" cy="9867960"/>
          </a:xfrm>
          <a:custGeom>
            <a:avLst/>
            <a:gdLst>
              <a:gd name="textAreaLeft" fmla="*/ 360 w 6735600"/>
              <a:gd name="textAreaRight" fmla="*/ 6735240 w 6735600"/>
              <a:gd name="textAreaTop" fmla="*/ 360 h 9867960"/>
              <a:gd name="textAreaBottom" fmla="*/ 9867600 h 9867960"/>
            </a:gdLst>
            <a:ahLst/>
            <a:rect l="textAreaLeft" t="textAreaTop" r="textAreaRight" b="textAreaBottom"/>
            <a:pathLst>
              <a:path w="21600" h="31644">
                <a:moveTo>
                  <a:pt x="5" y="0"/>
                </a:moveTo>
                <a:arcTo wR="5" hR="5" stAng="16200000" swAng="-5400000"/>
                <a:lnTo>
                  <a:pt x="0" y="31639"/>
                </a:lnTo>
                <a:arcTo wR="5" hR="5" stAng="10800000" swAng="-5400000"/>
                <a:lnTo>
                  <a:pt x="21595" y="31644"/>
                </a:lnTo>
                <a:arcTo wR="5" hR="5" stAng="5400000" swAng="-5400000"/>
                <a:lnTo>
                  <a:pt x="21600" y="5"/>
                </a:lnTo>
                <a:arcTo wR="5" hR="5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0" y="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814920" y="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1"/>
          <p:cNvSpPr>
            <a:spLocks noGrp="1"/>
          </p:cNvSpPr>
          <p:nvPr>
            <p:ph type="sldImg"/>
          </p:nvPr>
        </p:nvSpPr>
        <p:spPr>
          <a:xfrm>
            <a:off x="695160" y="739440"/>
            <a:ext cx="5343840" cy="369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 type="body"/>
          </p:nvPr>
        </p:nvSpPr>
        <p:spPr>
          <a:xfrm>
            <a:off x="673200" y="4686120"/>
            <a:ext cx="5387760" cy="443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0" y="937116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 type="sldNum" idx="2"/>
          </p:nvPr>
        </p:nvSpPr>
        <p:spPr>
          <a:xfrm>
            <a:off x="3814560" y="9370800"/>
            <a:ext cx="2917800" cy="4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CDA55DFC-FF8C-4458-A1E4-0DEB6408A6A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sldImg"/>
          </p:nvPr>
        </p:nvSpPr>
        <p:spPr>
          <a:xfrm>
            <a:off x="695160" y="739800"/>
            <a:ext cx="5345280" cy="3700440"/>
          </a:xfrm>
          <a:prstGeom prst="rect">
            <a:avLst/>
          </a:prstGeom>
          <a:ln w="0">
            <a:noFill/>
          </a:ln>
        </p:spPr>
      </p:sp>
      <p:sp>
        <p:nvSpPr>
          <p:cNvPr id="97" name="PlaceHolder 2"/>
          <p:cNvSpPr>
            <a:spLocks noGrp="1"/>
          </p:cNvSpPr>
          <p:nvPr>
            <p:ph type="body"/>
          </p:nvPr>
        </p:nvSpPr>
        <p:spPr>
          <a:xfrm>
            <a:off x="672840" y="4686120"/>
            <a:ext cx="5389560" cy="443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3814920" y="937116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57D756DB-716D-4676-A031-1E5E33889804}" type="slidenum"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A383B2F-CB07-4B8F-A65F-7695A2A02DF2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891360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360" y="3963600"/>
            <a:ext cx="891360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5E2DEEB-2BF1-4986-B92B-368D09685CFA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36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268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0105CDA-820D-4900-8CE9-A98390F3B70C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280" y="16002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2840" y="16002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360" y="39636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280" y="39636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2840" y="39636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1B7FDA0-BF6E-4404-B4DC-E97A1159977E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360" y="1600200"/>
            <a:ext cx="891360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381D22E-901B-4DC0-BCC7-D3FA4354C4B9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891360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F462E98-2B42-47E7-9738-4E8538B58659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032F53C-3EC4-4CBE-B483-D1FCA0B49514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ED58F94-0116-47A7-A5C8-5652E3FE7E24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360" y="274680"/>
            <a:ext cx="891360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CB2DF99-A4B8-4B93-A920-B08215F445FC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36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77B471E-FEE1-4E1F-B059-F2893F26D1F4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268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5C2D2A7-536E-4F49-A046-610C49B78B06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360" y="3963600"/>
            <a:ext cx="891360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F4BA53E-313E-4B63-994D-3D9150BC6AA1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360" y="1600200"/>
            <a:ext cx="891360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495360" y="6245280"/>
            <a:ext cx="231120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3384720" y="6245280"/>
            <a:ext cx="313668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>
          <a:xfrm>
            <a:off x="7099200" y="6245280"/>
            <a:ext cx="230976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A16F6817-7820-49E3-A011-09E86F884ECA}" type="slidenum">
              <a:rPr b="0" lang="en-US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"/>
          <p:cNvSpPr/>
          <p:nvPr/>
        </p:nvSpPr>
        <p:spPr>
          <a:xfrm>
            <a:off x="4905000" y="1662120"/>
            <a:ext cx="3745800" cy="188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1640">
              <a:lnSpc>
                <a:spcPct val="120000"/>
              </a:lnSpc>
              <a:tabLst>
                <a:tab algn="l" pos="0"/>
                <a:tab algn="l" pos="343080"/>
                <a:tab algn="l" pos="1257480"/>
                <a:tab algn="l" pos="2171880"/>
                <a:tab algn="l" pos="3086280"/>
                <a:tab algn="l" pos="4000680"/>
                <a:tab algn="l" pos="4915080"/>
                <a:tab algn="l" pos="5829480"/>
                <a:tab algn="l" pos="6743880"/>
                <a:tab algn="l" pos="7658280"/>
                <a:tab algn="l" pos="8572680"/>
                <a:tab algn="l" pos="9487080"/>
                <a:tab algn="l" pos="1040148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gp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delta mouse: head to tai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1640">
              <a:lnSpc>
                <a:spcPct val="120000"/>
              </a:lnSpc>
              <a:tabLst>
                <a:tab algn="l" pos="0"/>
                <a:tab algn="l" pos="343080"/>
                <a:tab algn="l" pos="1257480"/>
                <a:tab algn="l" pos="2171880"/>
                <a:tab algn="l" pos="3086280"/>
                <a:tab algn="l" pos="4000680"/>
                <a:tab algn="l" pos="4915080"/>
                <a:tab algn="l" pos="5829480"/>
                <a:tab algn="l" pos="6743880"/>
                <a:tab algn="l" pos="7658280"/>
                <a:tab algn="l" pos="8572680"/>
                <a:tab algn="l" pos="9487080"/>
                <a:tab algn="l" pos="1040148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.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gp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delta mouse: head to hea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1640">
              <a:lnSpc>
                <a:spcPct val="120000"/>
              </a:lnSpc>
              <a:tabLst>
                <a:tab algn="l" pos="0"/>
                <a:tab algn="l" pos="343080"/>
                <a:tab algn="l" pos="1257480"/>
                <a:tab algn="l" pos="2171880"/>
                <a:tab algn="l" pos="3086280"/>
                <a:tab algn="l" pos="4000680"/>
                <a:tab algn="l" pos="4915080"/>
                <a:tab algn="l" pos="5829480"/>
                <a:tab algn="l" pos="6743880"/>
                <a:tab algn="l" pos="7658280"/>
                <a:tab algn="l" pos="8572680"/>
                <a:tab algn="l" pos="9487080"/>
                <a:tab algn="l" pos="1040148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.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gp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delta mouse: tail to tai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1640">
              <a:lnSpc>
                <a:spcPct val="120000"/>
              </a:lnSpc>
              <a:tabLst>
                <a:tab algn="l" pos="0"/>
                <a:tab algn="l" pos="343080"/>
                <a:tab algn="l" pos="1257480"/>
                <a:tab algn="l" pos="2171880"/>
                <a:tab algn="l" pos="3086280"/>
                <a:tab algn="l" pos="4000680"/>
                <a:tab algn="l" pos="4915080"/>
                <a:tab algn="l" pos="5829480"/>
                <a:tab algn="l" pos="6743880"/>
                <a:tab algn="l" pos="7658280"/>
                <a:tab algn="l" pos="8572680"/>
                <a:tab algn="l" pos="9487080"/>
                <a:tab algn="l" pos="1040148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.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gp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delta rat: head to tai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1640">
              <a:lnSpc>
                <a:spcPct val="120000"/>
              </a:lnSpc>
              <a:tabLst>
                <a:tab algn="l" pos="0"/>
                <a:tab algn="l" pos="343080"/>
                <a:tab algn="l" pos="1257480"/>
                <a:tab algn="l" pos="2171880"/>
                <a:tab algn="l" pos="3086280"/>
                <a:tab algn="l" pos="4000680"/>
                <a:tab algn="l" pos="4915080"/>
                <a:tab algn="l" pos="5829480"/>
                <a:tab algn="l" pos="6743880"/>
                <a:tab algn="l" pos="7658280"/>
                <a:tab algn="l" pos="8572680"/>
                <a:tab algn="l" pos="9487080"/>
                <a:tab algn="l" pos="1040148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.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gp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delta rat: head to hea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1640">
              <a:lnSpc>
                <a:spcPct val="120000"/>
              </a:lnSpc>
              <a:tabLst>
                <a:tab algn="l" pos="0"/>
                <a:tab algn="l" pos="343080"/>
                <a:tab algn="l" pos="1257480"/>
                <a:tab algn="l" pos="2171880"/>
                <a:tab algn="l" pos="3086280"/>
                <a:tab algn="l" pos="4000680"/>
                <a:tab algn="l" pos="4915080"/>
                <a:tab algn="l" pos="5829480"/>
                <a:tab algn="l" pos="6743880"/>
                <a:tab algn="l" pos="7658280"/>
                <a:tab algn="l" pos="8572680"/>
                <a:tab algn="l" pos="9487080"/>
                <a:tab algn="l" pos="1040148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.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gp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delta rat: tail to tai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1640">
              <a:lnSpc>
                <a:spcPct val="120000"/>
              </a:lnSpc>
              <a:tabLst>
                <a:tab algn="l" pos="0"/>
                <a:tab algn="l" pos="343080"/>
                <a:tab algn="l" pos="1257480"/>
                <a:tab algn="l" pos="2171880"/>
                <a:tab algn="l" pos="3086280"/>
                <a:tab algn="l" pos="4000680"/>
                <a:tab algn="l" pos="4915080"/>
                <a:tab algn="l" pos="5829480"/>
                <a:tab algn="l" pos="6743880"/>
                <a:tab algn="l" pos="7658280"/>
                <a:tab algn="l" pos="8572680"/>
                <a:tab algn="l" pos="9487080"/>
                <a:tab algn="l" pos="1040148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[2%(w/v) agarose gel, 100V, 40 min]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568520" y="4781520"/>
            <a:ext cx="1871640" cy="217440"/>
          </a:xfrm>
          <a:prstGeom prst="rightArrow">
            <a:avLst>
              <a:gd name="adj1" fmla="val 57713"/>
              <a:gd name="adj2" fmla="val 116800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440160" y="4781520"/>
            <a:ext cx="1871640" cy="217440"/>
          </a:xfrm>
          <a:prstGeom prst="rightArrow">
            <a:avLst>
              <a:gd name="adj1" fmla="val 57713"/>
              <a:gd name="adj2" fmla="val 116800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H="1">
            <a:off x="1569960" y="5357880"/>
            <a:ext cx="1873440" cy="217440"/>
          </a:xfrm>
          <a:prstGeom prst="rightArrow">
            <a:avLst>
              <a:gd name="adj1" fmla="val 57713"/>
              <a:gd name="adj2" fmla="val 116913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440160" y="5357880"/>
            <a:ext cx="1871640" cy="217440"/>
          </a:xfrm>
          <a:prstGeom prst="rightArrow">
            <a:avLst>
              <a:gd name="adj1" fmla="val 57713"/>
              <a:gd name="adj2" fmla="val 116800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568520" y="5932440"/>
            <a:ext cx="1871640" cy="217440"/>
          </a:xfrm>
          <a:prstGeom prst="rightArrow">
            <a:avLst>
              <a:gd name="adj1" fmla="val 57713"/>
              <a:gd name="adj2" fmla="val 116800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H="1">
            <a:off x="3438360" y="5932440"/>
            <a:ext cx="1872000" cy="217440"/>
          </a:xfrm>
          <a:prstGeom prst="rightArrow">
            <a:avLst>
              <a:gd name="adj1" fmla="val 57713"/>
              <a:gd name="adj2" fmla="val 116823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865600" y="4757760"/>
            <a:ext cx="215640" cy="1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H="1">
            <a:off x="3587400" y="5033880"/>
            <a:ext cx="219240" cy="18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793960" y="450072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057480" y="5337000"/>
            <a:ext cx="216000" cy="18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H="1">
            <a:off x="3866760" y="6186600"/>
            <a:ext cx="219240" cy="1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H="1">
            <a:off x="3583080" y="5610240"/>
            <a:ext cx="218880" cy="1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840040" y="5908680"/>
            <a:ext cx="217440" cy="1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988000" y="50752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588120" y="55627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588120" y="49942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870360" y="614196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770200" y="566568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5506920" y="4710240"/>
            <a:ext cx="237384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ead to tail: 661 b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ead to head: 500 b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ail to tail: 822 b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057400" y="1228680"/>
            <a:ext cx="795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994120" y="1228680"/>
            <a:ext cx="7189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060640" y="870120"/>
            <a:ext cx="79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ous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150000" y="892080"/>
            <a:ext cx="41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a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63600" y="541440"/>
            <a:ext cx="839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ambda EG10 transgenes are integrated in the genome as a head to tail manner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" descr=""/>
          <p:cNvPicPr/>
          <p:nvPr/>
        </p:nvPicPr>
        <p:blipFill>
          <a:blip r:embed="rId1"/>
          <a:stretch/>
        </p:blipFill>
        <p:spPr>
          <a:xfrm>
            <a:off x="2057400" y="1517760"/>
            <a:ext cx="2071800" cy="2847960"/>
          </a:xfrm>
          <a:prstGeom prst="rect">
            <a:avLst/>
          </a:prstGeom>
          <a:ln w="0">
            <a:noFill/>
          </a:ln>
        </p:spPr>
      </p:pic>
      <p:sp>
        <p:nvSpPr>
          <p:cNvPr id="75" name=""/>
          <p:cNvSpPr/>
          <p:nvPr/>
        </p:nvSpPr>
        <p:spPr>
          <a:xfrm>
            <a:off x="2076840" y="1181160"/>
            <a:ext cx="2098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1   2   3   4   5   6    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6" name=""/>
          <p:cNvCxnSpPr/>
          <p:nvPr/>
        </p:nvCxnSpPr>
        <p:spPr>
          <a:xfrm>
            <a:off x="1746360" y="3289320"/>
            <a:ext cx="240480" cy="2160"/>
          </a:xfrm>
          <a:prstGeom prst="bentConnector3">
            <a:avLst>
              <a:gd name="adj1" fmla="val 49925"/>
            </a:avLst>
          </a:prstGeom>
          <a:ln w="9360">
            <a:solidFill>
              <a:srgbClr val="000000"/>
            </a:solidFill>
            <a:round/>
          </a:ln>
        </p:spPr>
      </p:cxnSp>
      <p:sp>
        <p:nvSpPr>
          <p:cNvPr id="77" name=""/>
          <p:cNvSpPr/>
          <p:nvPr/>
        </p:nvSpPr>
        <p:spPr>
          <a:xfrm>
            <a:off x="4098960" y="2770200"/>
            <a:ext cx="216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098960" y="2922480"/>
            <a:ext cx="216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4098960" y="3075120"/>
            <a:ext cx="216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4098960" y="3303720"/>
            <a:ext cx="216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098960" y="3749760"/>
            <a:ext cx="216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4295880" y="263988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35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4295880" y="279252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7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4297320" y="294480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7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297320" y="3102120"/>
            <a:ext cx="52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0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275000" y="3605040"/>
            <a:ext cx="564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5472000" y="6280200"/>
            <a:ext cx="3873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imer H: 5’-CTGAATGGTACGGATACTCGCAC-3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imer T: 5’-GGAAGAACGCGGGATGTTCATTC-3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2157480" y="476424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4030560" y="47656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flipV="1">
            <a:off x="4030200" y="592452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flipV="1">
            <a:off x="2157120" y="53524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flipV="1" rot="10800000">
            <a:off x="4025880" y="534456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flipV="1" rot="10800000">
            <a:off x="2154240" y="59212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G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34920" y="66600"/>
            <a:ext cx="160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uppl. Fig. 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855720" y="305928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661 b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7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10T03:26:47Z</dcterms:created>
  <dc:creator>dgm2</dc:creator>
  <dc:description/>
  <dc:language>en-US</dc:language>
  <cp:lastModifiedBy>masumura</cp:lastModifiedBy>
  <cp:lastPrinted>2015-08-31T08:41:32Z</cp:lastPrinted>
  <dcterms:modified xsi:type="dcterms:W3CDTF">2015-10-01T07:44:08Z</dcterms:modified>
  <cp:revision>260</cp:revision>
  <dc:subject/>
  <dc:title>スライド 1</dc:title>
</cp:coreProperties>
</file>